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8" d="100"/>
          <a:sy n="48" d="100"/>
        </p:scale>
        <p:origin x="235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1135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4199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7948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7540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2869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7101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5160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060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5175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5200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9627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C06D7-57AA-4FA4-A54F-151A49FA1EA3}" type="datetimeFigureOut">
              <a:rPr lang="en-GB" smtClean="0"/>
              <a:t>15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A5B87-7DBB-46CF-9EC3-875F5D3702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1576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9000" contrast="-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662" y="1411357"/>
            <a:ext cx="6460434" cy="59436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18662" y="7658390"/>
            <a:ext cx="6460434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SF5: </a:t>
            </a:r>
            <a:r>
              <a:rPr lang="en-GB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Uncropped </a:t>
            </a:r>
            <a:r>
              <a:rPr lang="en-GB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riginal gel image for Figure 3 </a:t>
            </a:r>
          </a:p>
          <a:p>
            <a:r>
              <a:rPr lang="en-GB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GB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okI</a:t>
            </a:r>
            <a:r>
              <a:rPr lang="en-GB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digestion</a:t>
            </a:r>
            <a:r>
              <a:rPr lang="en-GB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GB" dirty="0"/>
              <a:t>.</a:t>
            </a:r>
            <a:endParaRPr lang="en-GB" sz="1600" b="1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20287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6000" contrast="-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55" y="1342754"/>
            <a:ext cx="6639339" cy="711641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9755" y="8732391"/>
            <a:ext cx="628153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</a:t>
            </a:r>
            <a:r>
              <a:rPr lang="en-GB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F6: </a:t>
            </a:r>
            <a:r>
              <a:rPr lang="en-GB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: </a:t>
            </a:r>
            <a:r>
              <a:rPr lang="en-GB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Uncropped </a:t>
            </a:r>
            <a:r>
              <a:rPr lang="en-GB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riginal gel image for Supplementary Figure SF1 (</a:t>
            </a:r>
            <a:r>
              <a:rPr lang="en-GB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aqI</a:t>
            </a:r>
            <a:r>
              <a:rPr lang="en-GB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digestion)</a:t>
            </a:r>
          </a:p>
        </p:txBody>
      </p:sp>
    </p:spTree>
    <p:extLst>
      <p:ext uri="{BB962C8B-B14F-4D97-AF65-F5344CB8AC3E}">
        <p14:creationId xmlns:p14="http://schemas.microsoft.com/office/powerpoint/2010/main" val="26937907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61000" contrast="-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443" y="1570383"/>
            <a:ext cx="6082749" cy="7017026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318052" y="8775990"/>
            <a:ext cx="628153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GB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</a:t>
            </a:r>
            <a:r>
              <a:rPr lang="en-GB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F7</a:t>
            </a:r>
            <a:r>
              <a:rPr lang="en-GB" sz="1600" b="1" dirty="0" smtClean="0">
                <a:solidFill>
                  <a:prstClr val="black"/>
                </a:solidFill>
              </a:rPr>
              <a:t>: </a:t>
            </a:r>
            <a:r>
              <a:rPr lang="en-GB" sz="1600" b="1" dirty="0" smtClean="0">
                <a:solidFill>
                  <a:prstClr val="black"/>
                </a:solidFill>
              </a:rPr>
              <a:t>Uncropped </a:t>
            </a:r>
            <a:r>
              <a:rPr lang="en-GB" sz="1600" b="1" dirty="0">
                <a:solidFill>
                  <a:prstClr val="black"/>
                </a:solidFill>
              </a:rPr>
              <a:t>original gel image for Supplementary Figure SF2 (</a:t>
            </a:r>
            <a:r>
              <a:rPr lang="en-GB" sz="1600" b="1" dirty="0" err="1">
                <a:solidFill>
                  <a:prstClr val="black"/>
                </a:solidFill>
              </a:rPr>
              <a:t>BsmI</a:t>
            </a:r>
            <a:r>
              <a:rPr lang="en-GB" sz="1600" b="1" dirty="0">
                <a:solidFill>
                  <a:prstClr val="black"/>
                </a:solidFill>
              </a:rPr>
              <a:t> digestion)</a:t>
            </a:r>
          </a:p>
        </p:txBody>
      </p:sp>
    </p:spTree>
    <p:extLst>
      <p:ext uri="{BB962C8B-B14F-4D97-AF65-F5344CB8AC3E}">
        <p14:creationId xmlns:p14="http://schemas.microsoft.com/office/powerpoint/2010/main" val="437604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</TotalTime>
  <Words>48</Words>
  <Application>Microsoft Office PowerPoint</Application>
  <PresentationFormat>A4 Paper (210x297 mm)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imam Mahmud</dc:creator>
  <cp:lastModifiedBy>Zimam Mahmud</cp:lastModifiedBy>
  <cp:revision>7</cp:revision>
  <dcterms:created xsi:type="dcterms:W3CDTF">2023-09-13T02:53:16Z</dcterms:created>
  <dcterms:modified xsi:type="dcterms:W3CDTF">2024-02-15T17:36:07Z</dcterms:modified>
</cp:coreProperties>
</file>